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6" r:id="rId2"/>
  </p:sldIdLst>
  <p:sldSz cx="6627813" cy="8229600"/>
  <p:notesSz cx="6797675" cy="9926638"/>
  <p:defaultTextStyle>
    <a:defPPr>
      <a:defRPr lang="en-US"/>
    </a:defPPr>
    <a:lvl1pPr marL="0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69" autoAdjust="0"/>
    <p:restoredTop sz="83730" autoAdjust="0"/>
  </p:normalViewPr>
  <p:slideViewPr>
    <p:cSldViewPr snapToGrid="0">
      <p:cViewPr varScale="1">
        <p:scale>
          <a:sx n="64" d="100"/>
          <a:sy n="64" d="100"/>
        </p:scale>
        <p:origin x="82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r">
              <a:defRPr sz="1200"/>
            </a:lvl1pPr>
          </a:lstStyle>
          <a:p>
            <a:fld id="{C5D40AFF-1C51-4ABB-BD6B-D0EE3408014B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49463" y="1241425"/>
            <a:ext cx="2698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61" tIns="45681" rIns="91361" bIns="45681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361" tIns="45681" rIns="91361" bIns="45681" rtlCol="0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r">
              <a:defRPr sz="1200"/>
            </a:lvl1pPr>
          </a:lstStyle>
          <a:p>
            <a:fld id="{63E91E67-22E1-4F8C-A6ED-04C89FD84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15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E91E67-22E1-4F8C-A6ED-04C89FD848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1211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7086" y="1346836"/>
            <a:ext cx="5633641" cy="2865120"/>
          </a:xfrm>
        </p:spPr>
        <p:txBody>
          <a:bodyPr anchor="b"/>
          <a:lstStyle>
            <a:lvl1pPr algn="ctr"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8477" y="4322446"/>
            <a:ext cx="4970860" cy="1986914"/>
          </a:xfrm>
        </p:spPr>
        <p:txBody>
          <a:bodyPr/>
          <a:lstStyle>
            <a:lvl1pPr marL="0" indent="0" algn="ctr">
              <a:buNone/>
              <a:defRPr sz="1740"/>
            </a:lvl1pPr>
            <a:lvl2pPr marL="331379" indent="0" algn="ctr">
              <a:buNone/>
              <a:defRPr sz="1450"/>
            </a:lvl2pPr>
            <a:lvl3pPr marL="662757" indent="0" algn="ctr">
              <a:buNone/>
              <a:defRPr sz="1305"/>
            </a:lvl3pPr>
            <a:lvl4pPr marL="994136" indent="0" algn="ctr">
              <a:buNone/>
              <a:defRPr sz="1160"/>
            </a:lvl4pPr>
            <a:lvl5pPr marL="1325514" indent="0" algn="ctr">
              <a:buNone/>
              <a:defRPr sz="1160"/>
            </a:lvl5pPr>
            <a:lvl6pPr marL="1656893" indent="0" algn="ctr">
              <a:buNone/>
              <a:defRPr sz="1160"/>
            </a:lvl6pPr>
            <a:lvl7pPr marL="1988271" indent="0" algn="ctr">
              <a:buNone/>
              <a:defRPr sz="1160"/>
            </a:lvl7pPr>
            <a:lvl8pPr marL="2319650" indent="0" algn="ctr">
              <a:buNone/>
              <a:defRPr sz="1160"/>
            </a:lvl8pPr>
            <a:lvl9pPr marL="2651028" indent="0" algn="ctr">
              <a:buNone/>
              <a:defRPr sz="116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36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76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43029" y="438150"/>
            <a:ext cx="1429122" cy="697420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5662" y="438150"/>
            <a:ext cx="4204519" cy="697420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65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52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2210" y="2051688"/>
            <a:ext cx="5716489" cy="3423284"/>
          </a:xfrm>
        </p:spPr>
        <p:txBody>
          <a:bodyPr anchor="b"/>
          <a:lstStyle>
            <a:lvl1pPr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210" y="5507358"/>
            <a:ext cx="5716489" cy="1800224"/>
          </a:xfrm>
        </p:spPr>
        <p:txBody>
          <a:bodyPr/>
          <a:lstStyle>
            <a:lvl1pPr marL="0" indent="0">
              <a:buNone/>
              <a:defRPr sz="1740">
                <a:solidFill>
                  <a:schemeClr val="tx1"/>
                </a:solidFill>
              </a:defRPr>
            </a:lvl1pPr>
            <a:lvl2pPr marL="331379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2pPr>
            <a:lvl3pPr marL="662757" indent="0">
              <a:buNone/>
              <a:defRPr sz="1305">
                <a:solidFill>
                  <a:schemeClr val="tx1">
                    <a:tint val="75000"/>
                  </a:schemeClr>
                </a:solidFill>
              </a:defRPr>
            </a:lvl3pPr>
            <a:lvl4pPr marL="994136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4pPr>
            <a:lvl5pPr marL="1325514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5pPr>
            <a:lvl6pPr marL="1656893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6pPr>
            <a:lvl7pPr marL="1988271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7pPr>
            <a:lvl8pPr marL="2319650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8pPr>
            <a:lvl9pPr marL="2651028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40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5662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5330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257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5" y="438152"/>
            <a:ext cx="5716489" cy="1590676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6526" y="2017396"/>
            <a:ext cx="2803875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6526" y="3006090"/>
            <a:ext cx="2803875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55331" y="2017396"/>
            <a:ext cx="2817684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55331" y="3006090"/>
            <a:ext cx="2817684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457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96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6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7684" y="1184912"/>
            <a:ext cx="3355330" cy="5848350"/>
          </a:xfrm>
        </p:spPr>
        <p:txBody>
          <a:bodyPr/>
          <a:lstStyle>
            <a:lvl1pPr>
              <a:defRPr sz="2319"/>
            </a:lvl1pPr>
            <a:lvl2pPr>
              <a:defRPr sz="2029"/>
            </a:lvl2pPr>
            <a:lvl3pPr>
              <a:defRPr sz="1740"/>
            </a:lvl3pPr>
            <a:lvl4pPr>
              <a:defRPr sz="1450"/>
            </a:lvl4pPr>
            <a:lvl5pPr>
              <a:defRPr sz="1450"/>
            </a:lvl5pPr>
            <a:lvl6pPr>
              <a:defRPr sz="1450"/>
            </a:lvl6pPr>
            <a:lvl7pPr>
              <a:defRPr sz="1450"/>
            </a:lvl7pPr>
            <a:lvl8pPr>
              <a:defRPr sz="1450"/>
            </a:lvl8pPr>
            <a:lvl9pPr>
              <a:defRPr sz="14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755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17684" y="1184912"/>
            <a:ext cx="3355330" cy="5848350"/>
          </a:xfrm>
        </p:spPr>
        <p:txBody>
          <a:bodyPr anchor="t"/>
          <a:lstStyle>
            <a:lvl1pPr marL="0" indent="0">
              <a:buNone/>
              <a:defRPr sz="2319"/>
            </a:lvl1pPr>
            <a:lvl2pPr marL="331379" indent="0">
              <a:buNone/>
              <a:defRPr sz="2029"/>
            </a:lvl2pPr>
            <a:lvl3pPr marL="662757" indent="0">
              <a:buNone/>
              <a:defRPr sz="1740"/>
            </a:lvl3pPr>
            <a:lvl4pPr marL="994136" indent="0">
              <a:buNone/>
              <a:defRPr sz="1450"/>
            </a:lvl4pPr>
            <a:lvl5pPr marL="1325514" indent="0">
              <a:buNone/>
              <a:defRPr sz="1450"/>
            </a:lvl5pPr>
            <a:lvl6pPr marL="1656893" indent="0">
              <a:buNone/>
              <a:defRPr sz="1450"/>
            </a:lvl6pPr>
            <a:lvl7pPr marL="1988271" indent="0">
              <a:buNone/>
              <a:defRPr sz="1450"/>
            </a:lvl7pPr>
            <a:lvl8pPr marL="2319650" indent="0">
              <a:buNone/>
              <a:defRPr sz="1450"/>
            </a:lvl8pPr>
            <a:lvl9pPr marL="2651028" indent="0">
              <a:buNone/>
              <a:defRPr sz="145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934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5662" y="438152"/>
            <a:ext cx="5716489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662" y="2190750"/>
            <a:ext cx="5716489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5662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95463" y="7627622"/>
            <a:ext cx="2236887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80893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44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62757" rtl="0" eaLnBrk="1" latinLnBrk="0" hangingPunct="1">
        <a:lnSpc>
          <a:spcPct val="90000"/>
        </a:lnSpc>
        <a:spcBef>
          <a:spcPct val="0"/>
        </a:spcBef>
        <a:buNone/>
        <a:defRPr sz="31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5689" indent="-165689" algn="l" defTabSz="662757" rtl="0" eaLnBrk="1" latinLnBrk="0" hangingPunct="1">
        <a:lnSpc>
          <a:spcPct val="90000"/>
        </a:lnSpc>
        <a:spcBef>
          <a:spcPts val="725"/>
        </a:spcBef>
        <a:buFont typeface="Arial" panose="020B0604020202020204" pitchFamily="34" charset="0"/>
        <a:buChar char="•"/>
        <a:defRPr sz="2029" kern="1200">
          <a:solidFill>
            <a:schemeClr val="tx1"/>
          </a:solidFill>
          <a:latin typeface="+mn-lt"/>
          <a:ea typeface="+mn-ea"/>
          <a:cs typeface="+mn-cs"/>
        </a:defRPr>
      </a:lvl1pPr>
      <a:lvl2pPr marL="49706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740" kern="1200">
          <a:solidFill>
            <a:schemeClr val="tx1"/>
          </a:solidFill>
          <a:latin typeface="+mn-lt"/>
          <a:ea typeface="+mn-ea"/>
          <a:cs typeface="+mn-cs"/>
        </a:defRPr>
      </a:lvl2pPr>
      <a:lvl3pPr marL="828446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450" kern="1200">
          <a:solidFill>
            <a:schemeClr val="tx1"/>
          </a:solidFill>
          <a:latin typeface="+mn-lt"/>
          <a:ea typeface="+mn-ea"/>
          <a:cs typeface="+mn-cs"/>
        </a:defRPr>
      </a:lvl3pPr>
      <a:lvl4pPr marL="1159825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491204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822582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2153961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485339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81671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1pPr>
      <a:lvl2pPr marL="331379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2pPr>
      <a:lvl3pPr marL="662757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3pPr>
      <a:lvl4pPr marL="994136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325514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656893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271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31965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651028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3267" y="3557225"/>
            <a:ext cx="1778312" cy="1837724"/>
          </a:xfrm>
          <a:prstGeom prst="rect">
            <a:avLst/>
          </a:prstGeom>
        </p:spPr>
      </p:pic>
      <p:pic>
        <p:nvPicPr>
          <p:cNvPr id="38" name="図 37"/>
          <p:cNvPicPr>
            <a:picLocks noChangeAspect="1"/>
          </p:cNvPicPr>
          <p:nvPr/>
        </p:nvPicPr>
        <p:blipFill rotWithShape="1">
          <a:blip r:embed="rId4"/>
          <a:srcRect t="10985" b="6275"/>
          <a:stretch/>
        </p:blipFill>
        <p:spPr>
          <a:xfrm>
            <a:off x="3619646" y="642418"/>
            <a:ext cx="1984196" cy="1190216"/>
          </a:xfrm>
          <a:prstGeom prst="rect">
            <a:avLst/>
          </a:prstGeom>
        </p:spPr>
      </p:pic>
      <p:pic>
        <p:nvPicPr>
          <p:cNvPr id="36" name="図 35"/>
          <p:cNvPicPr>
            <a:picLocks noChangeAspect="1"/>
          </p:cNvPicPr>
          <p:nvPr/>
        </p:nvPicPr>
        <p:blipFill rotWithShape="1">
          <a:blip r:embed="rId5"/>
          <a:srcRect t="9459" b="7801"/>
          <a:stretch/>
        </p:blipFill>
        <p:spPr>
          <a:xfrm>
            <a:off x="3613523" y="2912904"/>
            <a:ext cx="1984194" cy="1190213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6"/>
          <a:srcRect t="12654" b="7179"/>
          <a:stretch/>
        </p:blipFill>
        <p:spPr>
          <a:xfrm>
            <a:off x="3627599" y="1814218"/>
            <a:ext cx="1970123" cy="1145018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 rotWithShape="1">
          <a:blip r:embed="rId7"/>
          <a:srcRect t="11753" b="8081"/>
          <a:stretch/>
        </p:blipFill>
        <p:spPr>
          <a:xfrm>
            <a:off x="3623558" y="4073843"/>
            <a:ext cx="1970123" cy="1145017"/>
          </a:xfrm>
          <a:prstGeom prst="rect">
            <a:avLst/>
          </a:prstGeom>
        </p:spPr>
      </p:pic>
      <p:sp>
        <p:nvSpPr>
          <p:cNvPr id="6" name="テキスト ボックス 4"/>
          <p:cNvSpPr txBox="1">
            <a:spLocks noChangeArrowheads="1"/>
          </p:cNvSpPr>
          <p:nvPr/>
        </p:nvSpPr>
        <p:spPr bwMode="auto">
          <a:xfrm>
            <a:off x="2705297" y="77506"/>
            <a:ext cx="113204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Figure </a:t>
            </a:r>
            <a:r>
              <a:rPr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1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1" name="正方形/長方形 80"/>
          <p:cNvSpPr/>
          <p:nvPr/>
        </p:nvSpPr>
        <p:spPr>
          <a:xfrm>
            <a:off x="1367831" y="2013043"/>
            <a:ext cx="917037" cy="2582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KD#1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2" name="正方形/長方形 81"/>
          <p:cNvSpPr/>
          <p:nvPr/>
        </p:nvSpPr>
        <p:spPr>
          <a:xfrm>
            <a:off x="1428408" y="414591"/>
            <a:ext cx="918569" cy="2582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rambled 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1361738" y="3570174"/>
            <a:ext cx="917037" cy="2582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KD#2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1690782" y="3787224"/>
            <a:ext cx="883311" cy="25823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FI 115±3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467239" y="5375329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 rot="10800000">
            <a:off x="3302193" y="5746996"/>
            <a:ext cx="353943" cy="180481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hagocytic activity</a:t>
            </a:r>
            <a:r>
              <a:rPr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MFI)</a:t>
            </a:r>
            <a:endParaRPr lang="en-US" altLang="ja-JP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2" name="正方形/長方形 111"/>
          <p:cNvSpPr/>
          <p:nvPr/>
        </p:nvSpPr>
        <p:spPr>
          <a:xfrm>
            <a:off x="3239521" y="699061"/>
            <a:ext cx="33374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4658448" y="4086754"/>
            <a:ext cx="990252" cy="2308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/o CMT93</a:t>
            </a:r>
            <a:endParaRPr lang="en-US" altLang="ja-JP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4713141" y="716062"/>
            <a:ext cx="941066" cy="2308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rambled</a:t>
            </a:r>
            <a:endParaRPr lang="en-US" altLang="ja-JP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4648869" y="1819636"/>
            <a:ext cx="982054" cy="2308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KD#1</a:t>
            </a:r>
            <a:endParaRPr lang="en-US" altLang="ja-JP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4648124" y="2952896"/>
            <a:ext cx="982054" cy="2308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KD#2</a:t>
            </a:r>
            <a:endParaRPr lang="en-US" altLang="ja-JP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76" name="直線コネクタ 75"/>
          <p:cNvCxnSpPr/>
          <p:nvPr/>
        </p:nvCxnSpPr>
        <p:spPr>
          <a:xfrm>
            <a:off x="4690332" y="717153"/>
            <a:ext cx="20674" cy="4270537"/>
          </a:xfrm>
          <a:prstGeom prst="line">
            <a:avLst/>
          </a:prstGeom>
          <a:ln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/>
          <p:cNvSpPr/>
          <p:nvPr/>
        </p:nvSpPr>
        <p:spPr>
          <a:xfrm>
            <a:off x="5654207" y="7822584"/>
            <a:ext cx="7080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n=7)</a:t>
            </a:r>
          </a:p>
        </p:txBody>
      </p:sp>
      <p:sp>
        <p:nvSpPr>
          <p:cNvPr id="40" name="正方形/長方形 39"/>
          <p:cNvSpPr/>
          <p:nvPr/>
        </p:nvSpPr>
        <p:spPr>
          <a:xfrm>
            <a:off x="3294020" y="5393730"/>
            <a:ext cx="33374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71" name="図 7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17925" y="5618962"/>
            <a:ext cx="1995879" cy="1995879"/>
          </a:xfrm>
          <a:prstGeom prst="rect">
            <a:avLst/>
          </a:prstGeom>
        </p:spPr>
      </p:pic>
      <p:sp>
        <p:nvSpPr>
          <p:cNvPr id="72" name="テキスト ボックス 71"/>
          <p:cNvSpPr txBox="1"/>
          <p:nvPr/>
        </p:nvSpPr>
        <p:spPr>
          <a:xfrm>
            <a:off x="1200533" y="7586561"/>
            <a:ext cx="653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naive</a:t>
            </a:r>
            <a:endParaRPr kumimoji="1" lang="ja-JP" altLang="en-US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810134" y="7586560"/>
            <a:ext cx="653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D#1</a:t>
            </a:r>
            <a:endParaRPr kumimoji="1" lang="ja-JP" altLang="en-US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2445135" y="7586559"/>
            <a:ext cx="653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D#2</a:t>
            </a:r>
            <a:endParaRPr kumimoji="1" lang="ja-JP" altLang="en-US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 rot="16200000">
            <a:off x="-404104" y="6336531"/>
            <a:ext cx="20688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atio of CD47mRNA expression / naïve CMT93</a:t>
            </a:r>
            <a:endParaRPr kumimoji="1" lang="ja-JP" altLang="en-US" sz="105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1989" y="5675179"/>
            <a:ext cx="2327098" cy="2166954"/>
          </a:xfrm>
          <a:prstGeom prst="rect">
            <a:avLst/>
          </a:prstGeom>
        </p:spPr>
      </p:pic>
      <p:cxnSp>
        <p:nvCxnSpPr>
          <p:cNvPr id="64" name="直線コネクタ 63"/>
          <p:cNvCxnSpPr/>
          <p:nvPr/>
        </p:nvCxnSpPr>
        <p:spPr>
          <a:xfrm>
            <a:off x="4224645" y="5787498"/>
            <a:ext cx="7898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正方形/長方形 36"/>
          <p:cNvSpPr/>
          <p:nvPr/>
        </p:nvSpPr>
        <p:spPr>
          <a:xfrm>
            <a:off x="4258925" y="5541480"/>
            <a:ext cx="7184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=0.034</a:t>
            </a:r>
          </a:p>
        </p:txBody>
      </p:sp>
      <p:pic>
        <p:nvPicPr>
          <p:cNvPr id="79" name="図 78"/>
          <p:cNvPicPr>
            <a:picLocks noChangeAspect="1"/>
          </p:cNvPicPr>
          <p:nvPr/>
        </p:nvPicPr>
        <p:blipFill rotWithShape="1">
          <a:blip r:embed="rId10"/>
          <a:srcRect l="38395" r="30413"/>
          <a:stretch/>
        </p:blipFill>
        <p:spPr>
          <a:xfrm>
            <a:off x="858347" y="1970520"/>
            <a:ext cx="1782350" cy="1838353"/>
          </a:xfrm>
          <a:prstGeom prst="rect">
            <a:avLst/>
          </a:prstGeom>
        </p:spPr>
      </p:pic>
      <p:pic>
        <p:nvPicPr>
          <p:cNvPr id="80" name="図 79"/>
          <p:cNvPicPr>
            <a:picLocks noChangeAspect="1"/>
          </p:cNvPicPr>
          <p:nvPr/>
        </p:nvPicPr>
        <p:blipFill rotWithShape="1">
          <a:blip r:embed="rId10"/>
          <a:srcRect l="7321" r="61100"/>
          <a:stretch/>
        </p:blipFill>
        <p:spPr>
          <a:xfrm>
            <a:off x="844825" y="345147"/>
            <a:ext cx="1811891" cy="1838353"/>
          </a:xfrm>
          <a:prstGeom prst="rect">
            <a:avLst/>
          </a:prstGeom>
        </p:spPr>
      </p:pic>
      <p:sp>
        <p:nvSpPr>
          <p:cNvPr id="86" name="正方形/長方形 85"/>
          <p:cNvSpPr/>
          <p:nvPr/>
        </p:nvSpPr>
        <p:spPr>
          <a:xfrm>
            <a:off x="1650157" y="595115"/>
            <a:ext cx="964560" cy="25823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FI 261±11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7" name="正方形/長方形 86"/>
          <p:cNvSpPr/>
          <p:nvPr/>
        </p:nvSpPr>
        <p:spPr>
          <a:xfrm>
            <a:off x="1670087" y="2242620"/>
            <a:ext cx="924701" cy="25823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FI 18.4±1</a:t>
            </a:r>
            <a:endParaRPr lang="en-US" altLang="ja-JP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83" name="直線矢印コネクタ 82"/>
          <p:cNvCxnSpPr/>
          <p:nvPr/>
        </p:nvCxnSpPr>
        <p:spPr>
          <a:xfrm>
            <a:off x="3675587" y="5285023"/>
            <a:ext cx="162436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/>
          <p:nvPr/>
        </p:nvSpPr>
        <p:spPr>
          <a:xfrm>
            <a:off x="5340663" y="5165123"/>
            <a:ext cx="526105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FSE</a:t>
            </a:r>
          </a:p>
        </p:txBody>
      </p:sp>
      <p:cxnSp>
        <p:nvCxnSpPr>
          <p:cNvPr id="90" name="直線矢印コネクタ 89"/>
          <p:cNvCxnSpPr/>
          <p:nvPr/>
        </p:nvCxnSpPr>
        <p:spPr>
          <a:xfrm flipH="1" flipV="1">
            <a:off x="3675587" y="4097984"/>
            <a:ext cx="9249" cy="1187039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テキスト ボックス 90"/>
          <p:cNvSpPr txBox="1"/>
          <p:nvPr/>
        </p:nvSpPr>
        <p:spPr>
          <a:xfrm rot="10800000">
            <a:off x="3506310" y="3496792"/>
            <a:ext cx="338554" cy="623112"/>
          </a:xfrm>
          <a:prstGeom prst="rect">
            <a:avLst/>
          </a:prstGeom>
          <a:noFill/>
          <a:ln>
            <a:noFill/>
          </a:ln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ount</a:t>
            </a:r>
            <a:endParaRPr lang="en-US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2382205" y="5151662"/>
            <a:ext cx="8242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</a:t>
            </a:r>
            <a:endParaRPr lang="en-US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 rot="16200000">
            <a:off x="317431" y="3363638"/>
            <a:ext cx="873957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ell number</a:t>
            </a:r>
            <a:endParaRPr lang="en-US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2395871" y="5288233"/>
            <a:ext cx="7080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n=4)</a:t>
            </a:r>
          </a:p>
        </p:txBody>
      </p:sp>
      <p:cxnSp>
        <p:nvCxnSpPr>
          <p:cNvPr id="95" name="直線矢印コネクタ 94"/>
          <p:cNvCxnSpPr/>
          <p:nvPr/>
        </p:nvCxnSpPr>
        <p:spPr>
          <a:xfrm>
            <a:off x="810208" y="5269308"/>
            <a:ext cx="1624360" cy="0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線矢印コネクタ 95"/>
          <p:cNvCxnSpPr/>
          <p:nvPr/>
        </p:nvCxnSpPr>
        <p:spPr>
          <a:xfrm flipH="1" flipV="1">
            <a:off x="790330" y="4092208"/>
            <a:ext cx="9249" cy="1187039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正方形/長方形 42"/>
          <p:cNvSpPr/>
          <p:nvPr/>
        </p:nvSpPr>
        <p:spPr>
          <a:xfrm>
            <a:off x="427075" y="699061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4516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835</TotalTime>
  <Words>51</Words>
  <Application>Microsoft Office PowerPoint</Application>
  <PresentationFormat>ユーザー設定</PresentationFormat>
  <Paragraphs>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nuki</dc:creator>
  <cp:lastModifiedBy>Sanuki</cp:lastModifiedBy>
  <cp:revision>404</cp:revision>
  <cp:lastPrinted>2017-05-16T06:38:32Z</cp:lastPrinted>
  <dcterms:created xsi:type="dcterms:W3CDTF">2014-04-30T02:57:16Z</dcterms:created>
  <dcterms:modified xsi:type="dcterms:W3CDTF">2018-06-10T09:52:50Z</dcterms:modified>
</cp:coreProperties>
</file>